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2"/>
  </p:notesMasterIdLst>
  <p:sldIdLst>
    <p:sldId id="1086" r:id="rId2"/>
    <p:sldId id="1073" r:id="rId3"/>
    <p:sldId id="1080" r:id="rId4"/>
    <p:sldId id="1084" r:id="rId5"/>
    <p:sldId id="1077" r:id="rId6"/>
    <p:sldId id="1075" r:id="rId7"/>
    <p:sldId id="1083" r:id="rId8"/>
    <p:sldId id="1085" r:id="rId9"/>
    <p:sldId id="1058" r:id="rId10"/>
    <p:sldId id="1078" r:id="rId11"/>
  </p:sldIdLst>
  <p:sldSz cx="18288000" cy="10287000"/>
  <p:notesSz cx="6858000" cy="9144000"/>
  <p:embeddedFontLst>
    <p:embeddedFont>
      <p:font typeface="Assistant" pitchFamily="2" charset="-79"/>
      <p:regular r:id="rId13"/>
      <p:bold r:id="rId14"/>
    </p:embeddedFont>
    <p:embeddedFont>
      <p:font typeface="Assistant Bold" charset="-79"/>
      <p:regular r:id="rId15"/>
      <p:bold r:id="rId16"/>
    </p:embeddedFont>
    <p:embeddedFont>
      <p:font typeface="Assistant ExtraBold" pitchFamily="2" charset="-79"/>
      <p:bold r:id="rId17"/>
    </p:embeddedFont>
    <p:embeddedFont>
      <p:font typeface="Assistant Regular" charset="-79"/>
      <p:regular r:id="rId18"/>
    </p:embeddedFont>
    <p:embeddedFont>
      <p:font typeface="Assistant SemiBold" pitchFamily="2" charset="-79"/>
      <p:bold r:id="rId19"/>
    </p:embeddedFont>
    <p:embeddedFont>
      <p:font typeface="Calibri" panose="020F0502020204030204" pitchFamily="34" charset="0"/>
      <p:regular r:id="rId20"/>
      <p:bold r:id="rId21"/>
      <p:italic r:id="rId22"/>
      <p:boldItalic r:id="rId23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1.fntdata"/><Relationship Id="rId18" Type="http://schemas.openxmlformats.org/officeDocument/2006/relationships/font" Target="fonts/font6.fntdata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font" Target="fonts/font9.fntdata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font" Target="fonts/font5.fntdata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font" Target="fonts/font4.fntdata"/><Relationship Id="rId20" Type="http://schemas.openxmlformats.org/officeDocument/2006/relationships/font" Target="fonts/font8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font" Target="fonts/font3.fntdata"/><Relationship Id="rId23" Type="http://schemas.openxmlformats.org/officeDocument/2006/relationships/font" Target="fonts/font11.fntdata"/><Relationship Id="rId10" Type="http://schemas.openxmlformats.org/officeDocument/2006/relationships/slide" Target="slides/slide9.xml"/><Relationship Id="rId19" Type="http://schemas.openxmlformats.org/officeDocument/2006/relationships/font" Target="fonts/font7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2.fntdata"/><Relationship Id="rId22" Type="http://schemas.openxmlformats.org/officeDocument/2006/relationships/font" Target="fonts/font10.fntdata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9511650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38175729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sv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jpeg"/><Relationship Id="rId4" Type="http://schemas.openxmlformats.org/officeDocument/2006/relationships/image" Target="../media/image7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sv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1990549"/>
            <a:chOff x="1573698" y="-152998"/>
            <a:chExt cx="7219847" cy="1987255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846660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6</a:t>
              </a:r>
            </a:p>
            <a:p>
              <a:pPr marL="0" lvl="0" indent="0" algn="ctr">
                <a:spcBef>
                  <a:spcPct val="0"/>
                </a:spcBef>
              </a:pPr>
              <a:endParaRPr lang="en-US" sz="3000" spc="874" dirty="0">
                <a:solidFill>
                  <a:schemeClr val="tx1">
                    <a:lumMod val="65000"/>
                    <a:lumOff val="35000"/>
                  </a:schemeClr>
                </a:solidFill>
                <a:latin typeface="Assistant SemiBold" panose="020B0604020202020204" pitchFamily="2" charset="-79"/>
                <a:cs typeface="Assistant SemiBold" panose="020B0604020202020204" pitchFamily="2" charset="-79"/>
              </a:endParaRP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Take Charge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ay active and switch up your routines to avoid negative healthy cu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step count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962900"/>
            <a:ext cx="11554505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Congratulate yourself for all the good habits you learn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Have patience for the bad habits you still have, the good ones will push out the bad ones </a:t>
            </a:r>
            <a:r>
              <a:rPr lang="en-US" sz="3000"/>
              <a:t>in time STICK WITH IT!</a:t>
            </a:r>
            <a:endParaRPr lang="en-US" sz="3000" dirty="0"/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weight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practice tipping the calorie balance towards losing weight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drink more water between meals?</a:t>
            </a:r>
            <a:br>
              <a:rPr lang="en-US" sz="3000" dirty="0">
                <a:latin typeface="Assistant" pitchFamily="2" charset="-79"/>
                <a:cs typeface="Assistant" pitchFamily="2" charset="-79"/>
              </a:rPr>
            </a:b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n does the snacking urge strike most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29256" y="2367826"/>
            <a:ext cx="10479651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’m always hungr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en returning home from being ou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ate at nigh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atching TV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en friends and family visi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057400" y="8642746"/>
            <a:ext cx="15468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Self-Awareness is key but we can learn from each other!</a:t>
            </a:r>
          </a:p>
          <a:p>
            <a:r>
              <a:rPr lang="en-US" sz="2800" dirty="0"/>
              <a:t>Our environment influences a lot of what we do, let’s share our current strategies for choosing healthy living when the snacking urge strikes!</a:t>
            </a:r>
          </a:p>
          <a:p>
            <a:endParaRPr lang="en-US" sz="2000" dirty="0"/>
          </a:p>
        </p:txBody>
      </p:sp>
      <p:pic>
        <p:nvPicPr>
          <p:cNvPr id="5" name="Graphic 4" descr="Cheers with solid fill">
            <a:extLst>
              <a:ext uri="{FF2B5EF4-FFF2-40B4-BE49-F238E27FC236}">
                <a16:creationId xmlns:a16="http://schemas.microsoft.com/office/drawing/2014/main" id="{E453062F-0802-4E53-B731-7167D3C0EE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31914" y="8642746"/>
            <a:ext cx="1449285" cy="14492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did you do to stay on track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59375" y="1475793"/>
            <a:ext cx="10479651" cy="6986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Strategies to stay healthy with the urge to snack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rab a piece of frui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rink water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o for a wal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Call a frien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Choose high fiber meals to curb later appetit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witch activities (ex: turn off TV &amp; read a book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et a change of scener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5468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These strategies are important to recognize and build on! You can always add more and use multiple approaches to stay on track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2" name="Picture 4" descr="How to set and achieve project milestones in Teamwork Projects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9186" y="2860626"/>
            <a:ext cx="6739467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2BC85AD-992E-4C43-A2E7-59BE1CB4B207}"/>
              </a:ext>
            </a:extLst>
          </p:cNvPr>
          <p:cNvSpPr txBox="1"/>
          <p:nvPr/>
        </p:nvSpPr>
        <p:spPr>
          <a:xfrm>
            <a:off x="11682381" y="7048500"/>
            <a:ext cx="55388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If you need to snack, try ½ cup high fiber cereal with a low-calorie milk, like almond milk. Aim for &lt;200 calories and &gt;5g fiber</a:t>
            </a:r>
          </a:p>
        </p:txBody>
      </p:sp>
      <p:pic>
        <p:nvPicPr>
          <p:cNvPr id="6" name="Graphic 5" descr="Apple with solid fill">
            <a:extLst>
              <a:ext uri="{FF2B5EF4-FFF2-40B4-BE49-F238E27FC236}">
                <a16:creationId xmlns:a16="http://schemas.microsoft.com/office/drawing/2014/main" id="{2A4B2619-C983-488B-992C-35842D57D04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0767981" y="6906703"/>
            <a:ext cx="914400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unger Cue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531362" y="2147115"/>
            <a:ext cx="12086744" cy="7879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u="sng" dirty="0"/>
              <a:t>Feelings Cue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Emotional eating: Lonely, bored, happy, stressed</a:t>
            </a:r>
          </a:p>
          <a:p>
            <a:endParaRPr lang="en-US" sz="1200" dirty="0"/>
          </a:p>
          <a:p>
            <a:r>
              <a:rPr lang="en-US" sz="3200" b="1" u="sng" dirty="0"/>
              <a:t>Context Cue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At a party being offered foo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A special occasion that centers around foo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Watching TV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Sporting event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Time of Day (i.e. it’s lunch time)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1400" dirty="0"/>
          </a:p>
          <a:p>
            <a:r>
              <a:rPr lang="en-US" sz="3200" b="1" u="sng" dirty="0"/>
              <a:t>Sense Cue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Seeing foo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Smelling foo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Tasting foo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1200" dirty="0"/>
          </a:p>
          <a:p>
            <a:r>
              <a:rPr lang="en-US" sz="3200" b="1" u="sng" dirty="0"/>
              <a:t>Physical Cue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Physical hunger, like stomach rumbling</a:t>
            </a:r>
          </a:p>
          <a:p>
            <a:pPr lvl="1"/>
            <a:endParaRPr lang="en-US" sz="3000" dirty="0"/>
          </a:p>
        </p:txBody>
      </p:sp>
      <p:pic>
        <p:nvPicPr>
          <p:cNvPr id="1026" name="Picture 2" descr="Funny Cartoon Popcorn Cola Watching Tv Stock Vector (Royalty Free)  596921147 | Shutterstock">
            <a:extLst>
              <a:ext uri="{FF2B5EF4-FFF2-40B4-BE49-F238E27FC236}">
                <a16:creationId xmlns:a16="http://schemas.microsoft.com/office/drawing/2014/main" id="{0E4ED00F-F9EA-43B5-B7B5-9AE1692C0BB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4" t="15216" r="4988" b="10573"/>
          <a:stretch/>
        </p:blipFill>
        <p:spPr bwMode="auto">
          <a:xfrm>
            <a:off x="10591799" y="3534715"/>
            <a:ext cx="6937311" cy="44398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Graphic 12" descr="Questions outline">
            <a:extLst>
              <a:ext uri="{FF2B5EF4-FFF2-40B4-BE49-F238E27FC236}">
                <a16:creationId xmlns:a16="http://schemas.microsoft.com/office/drawing/2014/main" id="{4B47F49B-00C7-4DDA-85AB-1C73A1AD44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574382" y="8139885"/>
            <a:ext cx="1752600" cy="17526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FB2F016-5DD2-47B8-900D-0D04084224C9}"/>
              </a:ext>
            </a:extLst>
          </p:cNvPr>
          <p:cNvSpPr txBox="1"/>
          <p:nvPr/>
        </p:nvSpPr>
        <p:spPr>
          <a:xfrm>
            <a:off x="12268200" y="8429270"/>
            <a:ext cx="526091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How many of these cues apply to you?</a:t>
            </a:r>
          </a:p>
          <a:p>
            <a:r>
              <a:rPr lang="en-US" sz="2400" b="1" dirty="0"/>
              <a:t>Share examples in the chat or raise your hand to share!</a:t>
            </a:r>
          </a:p>
        </p:txBody>
      </p:sp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cues become habit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B424D6-A28B-49F1-8363-7F1E55AC779F}"/>
              </a:ext>
            </a:extLst>
          </p:cNvPr>
          <p:cNvSpPr txBox="1"/>
          <p:nvPr/>
        </p:nvSpPr>
        <p:spPr>
          <a:xfrm>
            <a:off x="1417320" y="1709391"/>
            <a:ext cx="16323623" cy="96641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/>
              <a:t>When you act on a food cue the same way over and over again, you build a HABIT.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200" dirty="0"/>
              <a:t>It becomes automatic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200" dirty="0"/>
              <a:t>It is hard to break habits, but EASY to build new habit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/>
          </a:p>
          <a:p>
            <a:pPr marL="514350" indent="-514350">
              <a:buAutoNum type="arabicPeriod"/>
            </a:pPr>
            <a:r>
              <a:rPr lang="en-US" sz="3200" dirty="0"/>
              <a:t>Breaking Bad Habits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Eating when you’re not physically hungry </a:t>
            </a:r>
            <a:r>
              <a:rPr lang="en-US" sz="3200" dirty="0">
                <a:sym typeface="Wingdings" panose="05000000000000000000" pitchFamily="2" charset="2"/>
              </a:rPr>
              <a:t> Drink water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Snack on carrot sticks instead of potato chips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Seltzer instead of soda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Skip the candy and snack aisle at the grocery store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Limit TV time</a:t>
            </a:r>
          </a:p>
          <a:p>
            <a:pPr lvl="1"/>
            <a:endParaRPr lang="en-US" sz="2400" dirty="0"/>
          </a:p>
          <a:p>
            <a:pPr marL="514350" indent="-514350">
              <a:buAutoNum type="arabicPeriod"/>
            </a:pPr>
            <a:r>
              <a:rPr lang="en-US" sz="3200" dirty="0"/>
              <a:t>Building Better Habits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Keep food out of sight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Fill up on veggies and high-fiber foods to keep hunger low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Eat at the table, make the meal the only activity 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Serve portioned food on a plate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Keep exercise stuff in plain sight</a:t>
            </a:r>
          </a:p>
          <a:p>
            <a:pPr marL="971550" lvl="1" indent="-514350">
              <a:buFont typeface="Wingdings" panose="05000000000000000000" pitchFamily="2" charset="2"/>
              <a:buChar char="Ø"/>
            </a:pPr>
            <a:r>
              <a:rPr lang="en-US" sz="3200" dirty="0"/>
              <a:t>Leave notes to motivate you on the fridge</a:t>
            </a:r>
          </a:p>
          <a:p>
            <a:endParaRPr lang="en-US" sz="3200" dirty="0"/>
          </a:p>
          <a:p>
            <a:r>
              <a:rPr lang="en-US" sz="3200" dirty="0"/>
              <a:t> </a:t>
            </a:r>
          </a:p>
        </p:txBody>
      </p:sp>
      <p:pic>
        <p:nvPicPr>
          <p:cNvPr id="6" name="Picture 2" descr="How to Visualize Serving Size for Portion Control | Muscle &amp; Fitness">
            <a:extLst>
              <a:ext uri="{FF2B5EF4-FFF2-40B4-BE49-F238E27FC236}">
                <a16:creationId xmlns:a16="http://schemas.microsoft.com/office/drawing/2014/main" id="{08BC2E5B-1B79-4BF0-8AA1-8B0DBEAADDB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19" r="21145"/>
          <a:stretch/>
        </p:blipFill>
        <p:spPr bwMode="auto">
          <a:xfrm>
            <a:off x="12702284" y="5516470"/>
            <a:ext cx="4785483" cy="45574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B9DD80C-5735-4E22-BDD5-2E6081F942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2298021" y="3341675"/>
            <a:ext cx="1213304" cy="14815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F9EDAD4-42D4-48F0-B122-796030C117E6}"/>
              </a:ext>
            </a:extLst>
          </p:cNvPr>
          <p:cNvSpPr txBox="1"/>
          <p:nvPr/>
        </p:nvSpPr>
        <p:spPr>
          <a:xfrm>
            <a:off x="13484740" y="2852826"/>
            <a:ext cx="4280053" cy="2369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THIS WEEK’S TIP: </a:t>
            </a:r>
          </a:p>
          <a:p>
            <a:r>
              <a:rPr lang="en-US" sz="2800" b="1" i="1" u="sng" dirty="0">
                <a:solidFill>
                  <a:srgbClr val="FF0000"/>
                </a:solidFill>
              </a:rPr>
              <a:t>Portion your Food!</a:t>
            </a:r>
          </a:p>
          <a:p>
            <a:r>
              <a:rPr lang="en-US" sz="2400" dirty="0"/>
              <a:t>Family style sounds nice, but only taking one helping can help you control your calories and help you reach your goals!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are your problem cue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629256" y="2413655"/>
            <a:ext cx="14906144" cy="47397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is ONE problem cue I can take charge by getting rid of this week? (select one)</a:t>
            </a:r>
          </a:p>
          <a:p>
            <a:endParaRPr lang="en-US" sz="18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ing in front of the TV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ing just because it is time to eat, but I’m not hungr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ing just because someone else is eating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ing because it is the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ing past the point of feeling satisfie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ing my feeling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Others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9218" name="Picture 2" descr="Why Enterprise SEO Needs a Champion">
            <a:extLst>
              <a:ext uri="{FF2B5EF4-FFF2-40B4-BE49-F238E27FC236}">
                <a16:creationId xmlns:a16="http://schemas.microsoft.com/office/drawing/2014/main" id="{77E00D8C-D5E9-43B6-8787-0468356D9B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6"/>
          <a:stretch/>
        </p:blipFill>
        <p:spPr bwMode="auto">
          <a:xfrm>
            <a:off x="11277600" y="7150608"/>
            <a:ext cx="5676900" cy="3136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90895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are your positive cue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629256" y="2413655"/>
            <a:ext cx="14906144" cy="60324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is at least ONE HEALTHY cue I can take charge by adding this week? (select all)</a:t>
            </a:r>
          </a:p>
          <a:p>
            <a:endParaRPr lang="en-US" sz="18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Change of scenery, like getting out of the kitchen to keep from snacking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Jog or walk in place while watching TV or on the phon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Stock up on veggies and fruit to snack on and keep them visibl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Leave notes around to help remind me of my goal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 at the table so I can focus on eat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Pick the healthy places and foods to eat when away from ho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Bring healthy snacks with me so I have a healthy option and see it when look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to the outside of the grocery store- where the fresh food is sol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a meal plan so I know what to eat and don’t make last minute decision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Others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9218" name="Picture 2" descr="Why Enterprise SEO Needs a Champion">
            <a:extLst>
              <a:ext uri="{FF2B5EF4-FFF2-40B4-BE49-F238E27FC236}">
                <a16:creationId xmlns:a16="http://schemas.microsoft.com/office/drawing/2014/main" id="{77E00D8C-D5E9-43B6-8787-0468356D9B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6"/>
          <a:stretch/>
        </p:blipFill>
        <p:spPr bwMode="auto">
          <a:xfrm>
            <a:off x="11277600" y="7150608"/>
            <a:ext cx="5676900" cy="3136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709365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Take Charge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75 min of exercise this week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lready at 75 minutes? ADD more, can you make it to 90 minutes? How about 100?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Eliminate at least one problem cue, and add at least one positive cue.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You can keep track of the cues that help and hinder your progress on your weekly tracker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90518" y="8494466"/>
            <a:ext cx="1276868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REMEMBER 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Portion your plates!</a:t>
            </a:r>
          </a:p>
          <a:p>
            <a:r>
              <a:rPr lang="en-US" sz="2800" dirty="0"/>
              <a:t>Skip the seconds, and plan your meals so you know how much you are eating at each meal.  This will help you feel MORE FULL on LESS FOOD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50</TotalTime>
  <Words>1009</Words>
  <Application>Microsoft Office PowerPoint</Application>
  <PresentationFormat>Custom</PresentationFormat>
  <Paragraphs>170</Paragraphs>
  <Slides>10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20" baseType="lpstr">
      <vt:lpstr>Assistant Regular</vt:lpstr>
      <vt:lpstr>Courier New</vt:lpstr>
      <vt:lpstr>Assistant SemiBold</vt:lpstr>
      <vt:lpstr>Assistant</vt:lpstr>
      <vt:lpstr>Calibri</vt:lpstr>
      <vt:lpstr>Wingdings</vt:lpstr>
      <vt:lpstr>Arial</vt:lpstr>
      <vt:lpstr>Assistant Bold</vt:lpstr>
      <vt:lpstr>Assistant Extra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239</cp:revision>
  <dcterms:created xsi:type="dcterms:W3CDTF">2006-08-16T00:00:00Z</dcterms:created>
  <dcterms:modified xsi:type="dcterms:W3CDTF">2023-11-03T20:48:45Z</dcterms:modified>
  <dc:identifier>DAE7nbwep5o</dc:identifier>
</cp:coreProperties>
</file>